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300" r:id="rId2"/>
  </p:sldIdLst>
  <p:sldSz cx="6858000" cy="5486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33FF"/>
    <a:srgbClr val="009AD0"/>
    <a:srgbClr val="8156B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701" autoAdjust="0"/>
    <p:restoredTop sz="94660"/>
  </p:normalViewPr>
  <p:slideViewPr>
    <p:cSldViewPr snapToGrid="0">
      <p:cViewPr>
        <p:scale>
          <a:sx n="400" d="100"/>
          <a:sy n="400" d="100"/>
        </p:scale>
        <p:origin x="-9370" y="-44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risten%20Witt\Documents\Thesis%20stuff\Results\kristen%2004102015%20urea%20env%20nd%20compiled%20env%20nd%20treatmen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risten%20Witt\Documents\Thesis%20stuff\kristen%2004102015%20urea%20env%20nd%20compiled%20env%20nd%20treatment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0210174828755061E-2"/>
          <c:y val="0.27562385627494218"/>
          <c:w val="0.94396816373844927"/>
          <c:h val="0.607414497538011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C$2</c:f>
              <c:strCache>
                <c:ptCount val="1"/>
                <c:pt idx="0">
                  <c:v>Env ND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3:$G$13</c:f>
                <c:numCache>
                  <c:formatCode>General</c:formatCode>
                  <c:ptCount val="11"/>
                  <c:pt idx="0">
                    <c:v>2.1253374399866294</c:v>
                  </c:pt>
                  <c:pt idx="1">
                    <c:v>0.51595506413438508</c:v>
                  </c:pt>
                  <c:pt idx="2">
                    <c:v>10.799647238153067</c:v>
                  </c:pt>
                  <c:pt idx="3">
                    <c:v>13.924938189555986</c:v>
                  </c:pt>
                  <c:pt idx="4">
                    <c:v>5.0987646326707949</c:v>
                  </c:pt>
                  <c:pt idx="5">
                    <c:v>0.15812325713806538</c:v>
                  </c:pt>
                  <c:pt idx="6">
                    <c:v>7.484446523142851</c:v>
                  </c:pt>
                  <c:pt idx="7">
                    <c:v>2.3309325606612346</c:v>
                  </c:pt>
                  <c:pt idx="8">
                    <c:v>7.3129817432141104</c:v>
                  </c:pt>
                  <c:pt idx="9">
                    <c:v>5.2862253730212734</c:v>
                  </c:pt>
                  <c:pt idx="10">
                    <c:v>6.8610429441508165</c:v>
                  </c:pt>
                </c:numCache>
              </c:numRef>
            </c:plus>
            <c:minus>
              <c:numRef>
                <c:f>Sheet1!$G$3:$G$13</c:f>
                <c:numCache>
                  <c:formatCode>General</c:formatCode>
                  <c:ptCount val="11"/>
                  <c:pt idx="0">
                    <c:v>2.1253374399866294</c:v>
                  </c:pt>
                  <c:pt idx="1">
                    <c:v>0.51595506413438508</c:v>
                  </c:pt>
                  <c:pt idx="2">
                    <c:v>10.799647238153067</c:v>
                  </c:pt>
                  <c:pt idx="3">
                    <c:v>13.924938189555986</c:v>
                  </c:pt>
                  <c:pt idx="4">
                    <c:v>5.0987646326707949</c:v>
                  </c:pt>
                  <c:pt idx="5">
                    <c:v>0.15812325713806538</c:v>
                  </c:pt>
                  <c:pt idx="6">
                    <c:v>7.484446523142851</c:v>
                  </c:pt>
                  <c:pt idx="7">
                    <c:v>2.3309325606612346</c:v>
                  </c:pt>
                  <c:pt idx="8">
                    <c:v>7.3129817432141104</c:v>
                  </c:pt>
                  <c:pt idx="9">
                    <c:v>5.2862253730212734</c:v>
                  </c:pt>
                  <c:pt idx="10">
                    <c:v>6.861042944150816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3:$B$13</c:f>
              <c:strCache>
                <c:ptCount val="11"/>
                <c:pt idx="0">
                  <c:v>HIV-1 Serum</c:v>
                </c:pt>
                <c:pt idx="1">
                  <c:v>Human serum</c:v>
                </c:pt>
                <c:pt idx="2">
                  <c:v>PGT121</c:v>
                </c:pt>
                <c:pt idx="3">
                  <c:v>PGT128</c:v>
                </c:pt>
                <c:pt idx="4">
                  <c:v>19b</c:v>
                </c:pt>
                <c:pt idx="5">
                  <c:v>39F</c:v>
                </c:pt>
                <c:pt idx="6">
                  <c:v>b6</c:v>
                </c:pt>
                <c:pt idx="7">
                  <c:v>b12</c:v>
                </c:pt>
                <c:pt idx="8">
                  <c:v>CD4-Ig</c:v>
                </c:pt>
                <c:pt idx="9">
                  <c:v>VRC01</c:v>
                </c:pt>
                <c:pt idx="10">
                  <c:v>F105</c:v>
                </c:pt>
              </c:strCache>
            </c:strRef>
          </c:cat>
          <c:val>
            <c:numRef>
              <c:f>Sheet1!$C$3:$C$13</c:f>
              <c:numCache>
                <c:formatCode>General</c:formatCode>
                <c:ptCount val="11"/>
                <c:pt idx="0">
                  <c:v>107.04923699736129</c:v>
                </c:pt>
                <c:pt idx="1">
                  <c:v>7.0638498674901573E-2</c:v>
                </c:pt>
                <c:pt idx="2">
                  <c:v>43.778108476590837</c:v>
                </c:pt>
                <c:pt idx="3">
                  <c:v>56.603703294046895</c:v>
                </c:pt>
                <c:pt idx="4">
                  <c:v>33.542601570276979</c:v>
                </c:pt>
                <c:pt idx="5">
                  <c:v>-1.6067803717387017</c:v>
                </c:pt>
                <c:pt idx="6">
                  <c:v>73.726579337921251</c:v>
                </c:pt>
                <c:pt idx="7">
                  <c:v>59.950570378441405</c:v>
                </c:pt>
                <c:pt idx="8">
                  <c:v>52.656849378563003</c:v>
                </c:pt>
                <c:pt idx="9">
                  <c:v>61.131613731592587</c:v>
                </c:pt>
                <c:pt idx="10">
                  <c:v>23.6288088402665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D93-485E-9A52-B7CE20D8D1EA}"/>
            </c:ext>
          </c:extLst>
        </c:ser>
        <c:ser>
          <c:idx val="1"/>
          <c:order val="1"/>
          <c:tx>
            <c:strRef>
              <c:f>Sheet1!$D$2</c:f>
              <c:strCache>
                <c:ptCount val="1"/>
                <c:pt idx="0">
                  <c:v>Env ND + first freeze thaw</c:v>
                </c:pt>
              </c:strCache>
            </c:strRef>
          </c:tx>
          <c:spPr>
            <a:solidFill>
              <a:schemeClr val="tx2">
                <a:lumMod val="60000"/>
                <a:lumOff val="4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  <a:effectLst/>
          </c:spPr>
          <c:invertIfNegative val="0"/>
          <c:cat>
            <c:strRef>
              <c:f>Sheet1!$B$3:$B$13</c:f>
              <c:strCache>
                <c:ptCount val="11"/>
                <c:pt idx="0">
                  <c:v>HIV-1 Serum</c:v>
                </c:pt>
                <c:pt idx="1">
                  <c:v>Human serum</c:v>
                </c:pt>
                <c:pt idx="2">
                  <c:v>PGT121</c:v>
                </c:pt>
                <c:pt idx="3">
                  <c:v>PGT128</c:v>
                </c:pt>
                <c:pt idx="4">
                  <c:v>19b</c:v>
                </c:pt>
                <c:pt idx="5">
                  <c:v>39F</c:v>
                </c:pt>
                <c:pt idx="6">
                  <c:v>b6</c:v>
                </c:pt>
                <c:pt idx="7">
                  <c:v>b12</c:v>
                </c:pt>
                <c:pt idx="8">
                  <c:v>CD4-Ig</c:v>
                </c:pt>
                <c:pt idx="9">
                  <c:v>VRC01</c:v>
                </c:pt>
                <c:pt idx="10">
                  <c:v>F105</c:v>
                </c:pt>
              </c:strCache>
            </c:strRef>
          </c:cat>
          <c:val>
            <c:numRef>
              <c:f>Sheet1!$D$3:$D$13</c:f>
              <c:numCache>
                <c:formatCode>General</c:formatCode>
                <c:ptCount val="11"/>
                <c:pt idx="1">
                  <c:v>-0.893651142373999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D93-485E-9A52-B7CE20D8D1EA}"/>
            </c:ext>
          </c:extLst>
        </c:ser>
        <c:ser>
          <c:idx val="2"/>
          <c:order val="2"/>
          <c:tx>
            <c:strRef>
              <c:f>Sheet1!$E$2</c:f>
              <c:strCache>
                <c:ptCount val="1"/>
                <c:pt idx="0">
                  <c:v>Env ND + second freeze thaw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bg1">
                  <a:lumMod val="50000"/>
                </a:scheme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I$3:$I$13</c:f>
                <c:numCache>
                  <c:formatCode>General</c:formatCode>
                  <c:ptCount val="11"/>
                  <c:pt idx="0">
                    <c:v>13.513366198743608</c:v>
                  </c:pt>
                  <c:pt idx="1">
                    <c:v>4.9222718901465325E-2</c:v>
                  </c:pt>
                  <c:pt idx="2">
                    <c:v>2.1507750469564484</c:v>
                  </c:pt>
                  <c:pt idx="3">
                    <c:v>7.9946297070761787</c:v>
                  </c:pt>
                  <c:pt idx="4">
                    <c:v>0.20546376615336995</c:v>
                  </c:pt>
                  <c:pt idx="5">
                    <c:v>1.015367718584905E-3</c:v>
                  </c:pt>
                  <c:pt idx="6">
                    <c:v>2.3523525813735904</c:v>
                  </c:pt>
                  <c:pt idx="7">
                    <c:v>3.573585617257462</c:v>
                  </c:pt>
                  <c:pt idx="8">
                    <c:v>0</c:v>
                  </c:pt>
                  <c:pt idx="9">
                    <c:v>1.7434989259811613</c:v>
                  </c:pt>
                  <c:pt idx="10">
                    <c:v>7.3374703558841528E-2</c:v>
                  </c:pt>
                </c:numCache>
              </c:numRef>
            </c:plus>
            <c:minus>
              <c:numRef>
                <c:f>Sheet1!$I$3:$I$13</c:f>
                <c:numCache>
                  <c:formatCode>General</c:formatCode>
                  <c:ptCount val="11"/>
                  <c:pt idx="0">
                    <c:v>13.513366198743608</c:v>
                  </c:pt>
                  <c:pt idx="1">
                    <c:v>4.9222718901465325E-2</c:v>
                  </c:pt>
                  <c:pt idx="2">
                    <c:v>2.1507750469564484</c:v>
                  </c:pt>
                  <c:pt idx="3">
                    <c:v>7.9946297070761787</c:v>
                  </c:pt>
                  <c:pt idx="4">
                    <c:v>0.20546376615336995</c:v>
                  </c:pt>
                  <c:pt idx="5">
                    <c:v>1.015367718584905E-3</c:v>
                  </c:pt>
                  <c:pt idx="6">
                    <c:v>2.3523525813735904</c:v>
                  </c:pt>
                  <c:pt idx="7">
                    <c:v>3.573585617257462</c:v>
                  </c:pt>
                  <c:pt idx="8">
                    <c:v>0</c:v>
                  </c:pt>
                  <c:pt idx="9">
                    <c:v>1.7434989259811613</c:v>
                  </c:pt>
                  <c:pt idx="10">
                    <c:v>7.337470355884152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3:$B$13</c:f>
              <c:strCache>
                <c:ptCount val="11"/>
                <c:pt idx="0">
                  <c:v>HIV-1 Serum</c:v>
                </c:pt>
                <c:pt idx="1">
                  <c:v>Human serum</c:v>
                </c:pt>
                <c:pt idx="2">
                  <c:v>PGT121</c:v>
                </c:pt>
                <c:pt idx="3">
                  <c:v>PGT128</c:v>
                </c:pt>
                <c:pt idx="4">
                  <c:v>19b</c:v>
                </c:pt>
                <c:pt idx="5">
                  <c:v>39F</c:v>
                </c:pt>
                <c:pt idx="6">
                  <c:v>b6</c:v>
                </c:pt>
                <c:pt idx="7">
                  <c:v>b12</c:v>
                </c:pt>
                <c:pt idx="8">
                  <c:v>CD4-Ig</c:v>
                </c:pt>
                <c:pt idx="9">
                  <c:v>VRC01</c:v>
                </c:pt>
                <c:pt idx="10">
                  <c:v>F105</c:v>
                </c:pt>
              </c:strCache>
            </c:strRef>
          </c:cat>
          <c:val>
            <c:numRef>
              <c:f>Sheet1!$E$3:$E$13</c:f>
              <c:numCache>
                <c:formatCode>General</c:formatCode>
                <c:ptCount val="11"/>
                <c:pt idx="0">
                  <c:v>41.370272412471074</c:v>
                </c:pt>
                <c:pt idx="1">
                  <c:v>-4.8139445996567076</c:v>
                </c:pt>
                <c:pt idx="2">
                  <c:v>18.043469601415378</c:v>
                </c:pt>
                <c:pt idx="3">
                  <c:v>63.374673761721525</c:v>
                </c:pt>
                <c:pt idx="4">
                  <c:v>2.4784328610722253</c:v>
                </c:pt>
                <c:pt idx="5">
                  <c:v>-4.0952354147819596</c:v>
                </c:pt>
                <c:pt idx="6">
                  <c:v>19.956021557758191</c:v>
                </c:pt>
                <c:pt idx="7">
                  <c:v>24.901690437416022</c:v>
                </c:pt>
                <c:pt idx="8">
                  <c:v>0</c:v>
                </c:pt>
                <c:pt idx="9">
                  <c:v>26.377799513552301</c:v>
                </c:pt>
                <c:pt idx="10">
                  <c:v>2.02235150506848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D93-485E-9A52-B7CE20D8D1EA}"/>
            </c:ext>
          </c:extLst>
        </c:ser>
        <c:ser>
          <c:idx val="3"/>
          <c:order val="3"/>
          <c:tx>
            <c:strRef>
              <c:f>Sheet1!$F$2</c:f>
              <c:strCache>
                <c:ptCount val="1"/>
                <c:pt idx="0">
                  <c:v>Env ND + urea</c:v>
                </c:pt>
              </c:strCache>
            </c:strRef>
          </c:tx>
          <c:spPr>
            <a:solidFill>
              <a:srgbClr val="008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J$3:$J$13</c:f>
                <c:numCache>
                  <c:formatCode>General</c:formatCode>
                  <c:ptCount val="11"/>
                  <c:pt idx="0">
                    <c:v>1.049737929</c:v>
                  </c:pt>
                  <c:pt idx="1">
                    <c:v>5.8310504390000002</c:v>
                  </c:pt>
                  <c:pt idx="2">
                    <c:v>2.3725290800000001</c:v>
                  </c:pt>
                  <c:pt idx="3">
                    <c:v>6.722263034</c:v>
                  </c:pt>
                  <c:pt idx="4">
                    <c:v>2.7922185599999998</c:v>
                  </c:pt>
                  <c:pt idx="5">
                    <c:v>0.53102008300000003</c:v>
                  </c:pt>
                  <c:pt idx="6">
                    <c:v>15.64412312</c:v>
                  </c:pt>
                  <c:pt idx="7">
                    <c:v>1.2583044059999999</c:v>
                  </c:pt>
                  <c:pt idx="8">
                    <c:v>10.143684159999999</c:v>
                  </c:pt>
                  <c:pt idx="9">
                    <c:v>16.332749310000001</c:v>
                  </c:pt>
                  <c:pt idx="10">
                    <c:v>29.706315310000001</c:v>
                  </c:pt>
                </c:numCache>
              </c:numRef>
            </c:plus>
            <c:minus>
              <c:numRef>
                <c:f>Sheet1!$J$3:$J$13</c:f>
                <c:numCache>
                  <c:formatCode>General</c:formatCode>
                  <c:ptCount val="11"/>
                  <c:pt idx="0">
                    <c:v>1.049737929</c:v>
                  </c:pt>
                  <c:pt idx="1">
                    <c:v>5.8310504390000002</c:v>
                  </c:pt>
                  <c:pt idx="2">
                    <c:v>2.3725290800000001</c:v>
                  </c:pt>
                  <c:pt idx="3">
                    <c:v>6.722263034</c:v>
                  </c:pt>
                  <c:pt idx="4">
                    <c:v>2.7922185599999998</c:v>
                  </c:pt>
                  <c:pt idx="5">
                    <c:v>0.53102008300000003</c:v>
                  </c:pt>
                  <c:pt idx="6">
                    <c:v>15.64412312</c:v>
                  </c:pt>
                  <c:pt idx="7">
                    <c:v>1.2583044059999999</c:v>
                  </c:pt>
                  <c:pt idx="8">
                    <c:v>10.143684159999999</c:v>
                  </c:pt>
                  <c:pt idx="9">
                    <c:v>16.332749310000001</c:v>
                  </c:pt>
                  <c:pt idx="10">
                    <c:v>29.70631531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3:$B$13</c:f>
              <c:strCache>
                <c:ptCount val="11"/>
                <c:pt idx="0">
                  <c:v>HIV-1 Serum</c:v>
                </c:pt>
                <c:pt idx="1">
                  <c:v>Human serum</c:v>
                </c:pt>
                <c:pt idx="2">
                  <c:v>PGT121</c:v>
                </c:pt>
                <c:pt idx="3">
                  <c:v>PGT128</c:v>
                </c:pt>
                <c:pt idx="4">
                  <c:v>19b</c:v>
                </c:pt>
                <c:pt idx="5">
                  <c:v>39F</c:v>
                </c:pt>
                <c:pt idx="6">
                  <c:v>b6</c:v>
                </c:pt>
                <c:pt idx="7">
                  <c:v>b12</c:v>
                </c:pt>
                <c:pt idx="8">
                  <c:v>CD4-Ig</c:v>
                </c:pt>
                <c:pt idx="9">
                  <c:v>VRC01</c:v>
                </c:pt>
                <c:pt idx="10">
                  <c:v>F105</c:v>
                </c:pt>
              </c:strCache>
            </c:strRef>
          </c:cat>
          <c:val>
            <c:numRef>
              <c:f>Sheet1!$F$3:$F$13</c:f>
              <c:numCache>
                <c:formatCode>General</c:formatCode>
                <c:ptCount val="11"/>
                <c:pt idx="0">
                  <c:v>102.55021179089935</c:v>
                </c:pt>
                <c:pt idx="1">
                  <c:v>9.9009304723777252</c:v>
                </c:pt>
                <c:pt idx="2">
                  <c:v>103.9411666004862</c:v>
                </c:pt>
                <c:pt idx="3">
                  <c:v>38.225817850542768</c:v>
                </c:pt>
                <c:pt idx="4">
                  <c:v>112.08770553327039</c:v>
                </c:pt>
                <c:pt idx="5">
                  <c:v>0.79173029932900929</c:v>
                </c:pt>
                <c:pt idx="6">
                  <c:v>47.650593003558662</c:v>
                </c:pt>
                <c:pt idx="7">
                  <c:v>117.12815636527813</c:v>
                </c:pt>
                <c:pt idx="8">
                  <c:v>99.144620638938093</c:v>
                </c:pt>
                <c:pt idx="9">
                  <c:v>96.653412040585053</c:v>
                </c:pt>
                <c:pt idx="10">
                  <c:v>90.4227847211247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D93-485E-9A52-B7CE20D8D1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8908448"/>
        <c:axId val="578906488"/>
      </c:barChart>
      <c:catAx>
        <c:axId val="578908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78906488"/>
        <c:crosses val="autoZero"/>
        <c:auto val="1"/>
        <c:lblAlgn val="ctr"/>
        <c:lblOffset val="100"/>
        <c:noMultiLvlLbl val="0"/>
      </c:catAx>
      <c:valAx>
        <c:axId val="5789064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789084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"/>
          <c:y val="2.089521663423128E-2"/>
          <c:w val="0.2740952792680017"/>
          <c:h val="0.2148626996240427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648331887439915E-2"/>
          <c:y val="6.0622569847043693E-2"/>
          <c:w val="0.93351668112560082"/>
          <c:h val="0.8133687977307936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C$23</c:f>
              <c:strCache>
                <c:ptCount val="1"/>
                <c:pt idx="0">
                  <c:v>Env ND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24:$G$36</c:f>
                <c:numCache>
                  <c:formatCode>General</c:formatCode>
                  <c:ptCount val="13"/>
                  <c:pt idx="0">
                    <c:v>10.768065460479004</c:v>
                  </c:pt>
                  <c:pt idx="1">
                    <c:v>0.61201457214792621</c:v>
                  </c:pt>
                  <c:pt idx="2">
                    <c:v>0.2165392991597323</c:v>
                  </c:pt>
                  <c:pt idx="3">
                    <c:v>6.7416853062497617E-2</c:v>
                  </c:pt>
                  <c:pt idx="4">
                    <c:v>0.27964314049794103</c:v>
                  </c:pt>
                  <c:pt idx="5">
                    <c:v>1.3533475399305808</c:v>
                  </c:pt>
                  <c:pt idx="6">
                    <c:v>6.9838695043493082E-3</c:v>
                  </c:pt>
                  <c:pt idx="7">
                    <c:v>11.595951572635654</c:v>
                  </c:pt>
                  <c:pt idx="8">
                    <c:v>7.8670503456227063</c:v>
                  </c:pt>
                  <c:pt idx="9">
                    <c:v>2.8808372972548861</c:v>
                  </c:pt>
                  <c:pt idx="10">
                    <c:v>2.6252675672930286</c:v>
                  </c:pt>
                  <c:pt idx="11">
                    <c:v>2.3931152928454047</c:v>
                  </c:pt>
                  <c:pt idx="12">
                    <c:v>2.4351360044130081</c:v>
                  </c:pt>
                </c:numCache>
              </c:numRef>
            </c:plus>
            <c:minus>
              <c:numRef>
                <c:f>Sheet1!$G$24:$G$36</c:f>
                <c:numCache>
                  <c:formatCode>General</c:formatCode>
                  <c:ptCount val="13"/>
                  <c:pt idx="0">
                    <c:v>10.768065460479004</c:v>
                  </c:pt>
                  <c:pt idx="1">
                    <c:v>0.61201457214792621</c:v>
                  </c:pt>
                  <c:pt idx="2">
                    <c:v>0.2165392991597323</c:v>
                  </c:pt>
                  <c:pt idx="3">
                    <c:v>6.7416853062497617E-2</c:v>
                  </c:pt>
                  <c:pt idx="4">
                    <c:v>0.27964314049794103</c:v>
                  </c:pt>
                  <c:pt idx="5">
                    <c:v>1.3533475399305808</c:v>
                  </c:pt>
                  <c:pt idx="6">
                    <c:v>6.9838695043493082E-3</c:v>
                  </c:pt>
                  <c:pt idx="7">
                    <c:v>11.595951572635654</c:v>
                  </c:pt>
                  <c:pt idx="8">
                    <c:v>7.8670503456227063</c:v>
                  </c:pt>
                  <c:pt idx="9">
                    <c:v>2.8808372972548861</c:v>
                  </c:pt>
                  <c:pt idx="10">
                    <c:v>2.6252675672930286</c:v>
                  </c:pt>
                  <c:pt idx="11">
                    <c:v>2.3931152928454047</c:v>
                  </c:pt>
                  <c:pt idx="12">
                    <c:v>2.43513600441300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24:$B$36</c:f>
              <c:strCache>
                <c:ptCount val="13"/>
                <c:pt idx="0">
                  <c:v>E51</c:v>
                </c:pt>
                <c:pt idx="1">
                  <c:v>17b</c:v>
                </c:pt>
                <c:pt idx="2">
                  <c:v>17b sCD4</c:v>
                </c:pt>
                <c:pt idx="3">
                  <c:v>C11</c:v>
                </c:pt>
                <c:pt idx="4">
                  <c:v>412D</c:v>
                </c:pt>
                <c:pt idx="5">
                  <c:v>35O22</c:v>
                </c:pt>
                <c:pt idx="6">
                  <c:v>4E10</c:v>
                </c:pt>
                <c:pt idx="7">
                  <c:v>98-6</c:v>
                </c:pt>
                <c:pt idx="8">
                  <c:v>F240</c:v>
                </c:pt>
                <c:pt idx="9">
                  <c:v>5F3</c:v>
                </c:pt>
                <c:pt idx="10">
                  <c:v>240-D</c:v>
                </c:pt>
                <c:pt idx="11">
                  <c:v>246-D</c:v>
                </c:pt>
                <c:pt idx="12">
                  <c:v>1D4</c:v>
                </c:pt>
              </c:strCache>
            </c:strRef>
          </c:cat>
          <c:val>
            <c:numRef>
              <c:f>Sheet1!$C$24:$C$36</c:f>
              <c:numCache>
                <c:formatCode>General</c:formatCode>
                <c:ptCount val="13"/>
                <c:pt idx="0">
                  <c:v>67.123150396178971</c:v>
                </c:pt>
                <c:pt idx="1">
                  <c:v>4.5921088768565212</c:v>
                </c:pt>
                <c:pt idx="2">
                  <c:v>1.986133290565014</c:v>
                </c:pt>
                <c:pt idx="3">
                  <c:v>-1.5981743731266356</c:v>
                </c:pt>
                <c:pt idx="4">
                  <c:v>-0.89054758120900168</c:v>
                </c:pt>
                <c:pt idx="5">
                  <c:v>108.81570382603162</c:v>
                </c:pt>
                <c:pt idx="6">
                  <c:v>109.4911457847498</c:v>
                </c:pt>
                <c:pt idx="7">
                  <c:v>58.403800963467361</c:v>
                </c:pt>
                <c:pt idx="8">
                  <c:v>49.648034872199332</c:v>
                </c:pt>
                <c:pt idx="9">
                  <c:v>56.227436327883765</c:v>
                </c:pt>
                <c:pt idx="10">
                  <c:v>26.184732669670215</c:v>
                </c:pt>
                <c:pt idx="11">
                  <c:v>23.030576419968039</c:v>
                </c:pt>
                <c:pt idx="12">
                  <c:v>6.57273036280057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45D-47AB-86B8-C4794450D4E0}"/>
            </c:ext>
          </c:extLst>
        </c:ser>
        <c:ser>
          <c:idx val="1"/>
          <c:order val="1"/>
          <c:tx>
            <c:strRef>
              <c:f>Sheet1!$D$23</c:f>
              <c:strCache>
                <c:ptCount val="1"/>
                <c:pt idx="0">
                  <c:v>Env ND + first freeze thaw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accent3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H$24:$H$36</c:f>
                <c:numCache>
                  <c:formatCode>General</c:formatCode>
                  <c:ptCount val="13"/>
                  <c:pt idx="0">
                    <c:v>2.7008715266503942</c:v>
                  </c:pt>
                  <c:pt idx="1">
                    <c:v>0.20882773139372707</c:v>
                  </c:pt>
                  <c:pt idx="2">
                    <c:v>0.21342174735995817</c:v>
                  </c:pt>
                  <c:pt idx="5">
                    <c:v>1.3338631734659132</c:v>
                  </c:pt>
                  <c:pt idx="6">
                    <c:v>0.80584420050830341</c:v>
                  </c:pt>
                </c:numCache>
              </c:numRef>
            </c:plus>
            <c:minus>
              <c:numRef>
                <c:f>Sheet1!$H$24:$H$36</c:f>
                <c:numCache>
                  <c:formatCode>General</c:formatCode>
                  <c:ptCount val="13"/>
                  <c:pt idx="0">
                    <c:v>2.7008715266503942</c:v>
                  </c:pt>
                  <c:pt idx="1">
                    <c:v>0.20882773139372707</c:v>
                  </c:pt>
                  <c:pt idx="2">
                    <c:v>0.21342174735995817</c:v>
                  </c:pt>
                  <c:pt idx="5">
                    <c:v>1.3338631734659132</c:v>
                  </c:pt>
                  <c:pt idx="6">
                    <c:v>0.805844200508303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24:$B$36</c:f>
              <c:strCache>
                <c:ptCount val="13"/>
                <c:pt idx="0">
                  <c:v>E51</c:v>
                </c:pt>
                <c:pt idx="1">
                  <c:v>17b</c:v>
                </c:pt>
                <c:pt idx="2">
                  <c:v>17b sCD4</c:v>
                </c:pt>
                <c:pt idx="3">
                  <c:v>C11</c:v>
                </c:pt>
                <c:pt idx="4">
                  <c:v>412D</c:v>
                </c:pt>
                <c:pt idx="5">
                  <c:v>35O22</c:v>
                </c:pt>
                <c:pt idx="6">
                  <c:v>4E10</c:v>
                </c:pt>
                <c:pt idx="7">
                  <c:v>98-6</c:v>
                </c:pt>
                <c:pt idx="8">
                  <c:v>F240</c:v>
                </c:pt>
                <c:pt idx="9">
                  <c:v>5F3</c:v>
                </c:pt>
                <c:pt idx="10">
                  <c:v>240-D</c:v>
                </c:pt>
                <c:pt idx="11">
                  <c:v>246-D</c:v>
                </c:pt>
                <c:pt idx="12">
                  <c:v>1D4</c:v>
                </c:pt>
              </c:strCache>
            </c:strRef>
          </c:cat>
          <c:val>
            <c:numRef>
              <c:f>Sheet1!$D$24:$D$36</c:f>
              <c:numCache>
                <c:formatCode>General</c:formatCode>
                <c:ptCount val="13"/>
                <c:pt idx="0">
                  <c:v>88.720192126845006</c:v>
                </c:pt>
                <c:pt idx="1">
                  <c:v>3.9542741665490412E-2</c:v>
                </c:pt>
                <c:pt idx="2">
                  <c:v>1.9575386037559181</c:v>
                </c:pt>
                <c:pt idx="5">
                  <c:v>107.24906629361634</c:v>
                </c:pt>
                <c:pt idx="6">
                  <c:v>107.859249574717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45D-47AB-86B8-C4794450D4E0}"/>
            </c:ext>
          </c:extLst>
        </c:ser>
        <c:ser>
          <c:idx val="2"/>
          <c:order val="2"/>
          <c:tx>
            <c:strRef>
              <c:f>Sheet1!$E$23</c:f>
              <c:strCache>
                <c:ptCount val="1"/>
                <c:pt idx="0">
                  <c:v>Env ND + second freeze thaw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bg1">
                  <a:lumMod val="50000"/>
                </a:scheme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I$24:$I$36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0.36195941028328632</c:v>
                  </c:pt>
                  <c:pt idx="2">
                    <c:v>0.51196758497132744</c:v>
                  </c:pt>
                  <c:pt idx="3">
                    <c:v>5.9359425038514844E-2</c:v>
                  </c:pt>
                  <c:pt idx="4">
                    <c:v>5.1805350590560878E-2</c:v>
                  </c:pt>
                  <c:pt idx="5">
                    <c:v>13.202222499701028</c:v>
                  </c:pt>
                  <c:pt idx="6">
                    <c:v>9.333520382967647</c:v>
                  </c:pt>
                  <c:pt idx="7">
                    <c:v>12.838783541325192</c:v>
                  </c:pt>
                  <c:pt idx="8">
                    <c:v>11.459643315652853</c:v>
                  </c:pt>
                  <c:pt idx="9">
                    <c:v>1.8825817587388236</c:v>
                  </c:pt>
                  <c:pt idx="10">
                    <c:v>1.3949223157443036</c:v>
                  </c:pt>
                  <c:pt idx="11">
                    <c:v>1.3527157423691376</c:v>
                  </c:pt>
                  <c:pt idx="12">
                    <c:v>0.87443187903174735</c:v>
                  </c:pt>
                </c:numCache>
              </c:numRef>
            </c:plus>
            <c:minus>
              <c:numRef>
                <c:f>Sheet1!$I$24:$I$36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0.36195941028328632</c:v>
                  </c:pt>
                  <c:pt idx="2">
                    <c:v>0.51196758497132744</c:v>
                  </c:pt>
                  <c:pt idx="3">
                    <c:v>5.9359425038514844E-2</c:v>
                  </c:pt>
                  <c:pt idx="4">
                    <c:v>5.1805350590560878E-2</c:v>
                  </c:pt>
                  <c:pt idx="5">
                    <c:v>13.202222499701028</c:v>
                  </c:pt>
                  <c:pt idx="6">
                    <c:v>9.333520382967647</c:v>
                  </c:pt>
                  <c:pt idx="7">
                    <c:v>12.838783541325192</c:v>
                  </c:pt>
                  <c:pt idx="8">
                    <c:v>11.459643315652853</c:v>
                  </c:pt>
                  <c:pt idx="9">
                    <c:v>1.8825817587388236</c:v>
                  </c:pt>
                  <c:pt idx="10">
                    <c:v>1.3949223157443036</c:v>
                  </c:pt>
                  <c:pt idx="11">
                    <c:v>1.3527157423691376</c:v>
                  </c:pt>
                  <c:pt idx="12">
                    <c:v>0.874431879031747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24:$B$36</c:f>
              <c:strCache>
                <c:ptCount val="13"/>
                <c:pt idx="0">
                  <c:v>E51</c:v>
                </c:pt>
                <c:pt idx="1">
                  <c:v>17b</c:v>
                </c:pt>
                <c:pt idx="2">
                  <c:v>17b sCD4</c:v>
                </c:pt>
                <c:pt idx="3">
                  <c:v>C11</c:v>
                </c:pt>
                <c:pt idx="4">
                  <c:v>412D</c:v>
                </c:pt>
                <c:pt idx="5">
                  <c:v>35O22</c:v>
                </c:pt>
                <c:pt idx="6">
                  <c:v>4E10</c:v>
                </c:pt>
                <c:pt idx="7">
                  <c:v>98-6</c:v>
                </c:pt>
                <c:pt idx="8">
                  <c:v>F240</c:v>
                </c:pt>
                <c:pt idx="9">
                  <c:v>5F3</c:v>
                </c:pt>
                <c:pt idx="10">
                  <c:v>240-D</c:v>
                </c:pt>
                <c:pt idx="11">
                  <c:v>246-D</c:v>
                </c:pt>
                <c:pt idx="12">
                  <c:v>1D4</c:v>
                </c:pt>
              </c:strCache>
            </c:strRef>
          </c:cat>
          <c:val>
            <c:numRef>
              <c:f>Sheet1!$E$24:$E$36</c:f>
              <c:numCache>
                <c:formatCode>General</c:formatCode>
                <c:ptCount val="13"/>
                <c:pt idx="0">
                  <c:v>0</c:v>
                </c:pt>
                <c:pt idx="1">
                  <c:v>-1.9306369427658927</c:v>
                </c:pt>
                <c:pt idx="2">
                  <c:v>-1.122558089406015</c:v>
                </c:pt>
                <c:pt idx="3">
                  <c:v>-3.6461301079999999</c:v>
                </c:pt>
                <c:pt idx="4">
                  <c:v>-2.6275679491463424</c:v>
                </c:pt>
                <c:pt idx="5">
                  <c:v>53.637805744514715</c:v>
                </c:pt>
                <c:pt idx="6">
                  <c:v>25.353873409284365</c:v>
                </c:pt>
                <c:pt idx="7">
                  <c:v>50.60076114644081</c:v>
                </c:pt>
                <c:pt idx="8">
                  <c:v>30.53605387680879</c:v>
                </c:pt>
                <c:pt idx="9">
                  <c:v>13.347355783908888</c:v>
                </c:pt>
                <c:pt idx="10">
                  <c:v>7.3219817133651777</c:v>
                </c:pt>
                <c:pt idx="11">
                  <c:v>8.4673438706886248</c:v>
                </c:pt>
                <c:pt idx="12">
                  <c:v>0.63317927338853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45D-47AB-86B8-C4794450D4E0}"/>
            </c:ext>
          </c:extLst>
        </c:ser>
        <c:ser>
          <c:idx val="3"/>
          <c:order val="3"/>
          <c:tx>
            <c:strRef>
              <c:f>Sheet1!$F$23</c:f>
              <c:strCache>
                <c:ptCount val="1"/>
                <c:pt idx="0">
                  <c:v>Env ND + urea</c:v>
                </c:pt>
              </c:strCache>
            </c:strRef>
          </c:tx>
          <c:spPr>
            <a:solidFill>
              <a:srgbClr val="008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J$24:$J$36</c:f>
                <c:numCache>
                  <c:formatCode>General</c:formatCode>
                  <c:ptCount val="13"/>
                  <c:pt idx="0">
                    <c:v>13.425083150000001</c:v>
                  </c:pt>
                  <c:pt idx="1">
                    <c:v>9.8162667234074874</c:v>
                  </c:pt>
                  <c:pt idx="2">
                    <c:v>3.5595895660000001</c:v>
                  </c:pt>
                  <c:pt idx="3">
                    <c:v>1.4686273320000001</c:v>
                  </c:pt>
                  <c:pt idx="4">
                    <c:v>1.1111044919999999</c:v>
                  </c:pt>
                  <c:pt idx="5">
                    <c:v>6.4715943899999999</c:v>
                  </c:pt>
                  <c:pt idx="6">
                    <c:v>18.09414414410135</c:v>
                  </c:pt>
                  <c:pt idx="7">
                    <c:v>2.7521427420000002</c:v>
                  </c:pt>
                  <c:pt idx="8">
                    <c:v>1.7082539940000001</c:v>
                  </c:pt>
                  <c:pt idx="9">
                    <c:v>2.9036421890000002</c:v>
                  </c:pt>
                  <c:pt idx="10">
                    <c:v>6.3071812859999996</c:v>
                  </c:pt>
                  <c:pt idx="11">
                    <c:v>18.65568193</c:v>
                  </c:pt>
                  <c:pt idx="12">
                    <c:v>6.0454841469999998</c:v>
                  </c:pt>
                </c:numCache>
              </c:numRef>
            </c:plus>
            <c:minus>
              <c:numRef>
                <c:f>Sheet1!$J$24:$J$36</c:f>
                <c:numCache>
                  <c:formatCode>General</c:formatCode>
                  <c:ptCount val="13"/>
                  <c:pt idx="0">
                    <c:v>13.425083150000001</c:v>
                  </c:pt>
                  <c:pt idx="1">
                    <c:v>9.8162667234074874</c:v>
                  </c:pt>
                  <c:pt idx="2">
                    <c:v>3.5595895660000001</c:v>
                  </c:pt>
                  <c:pt idx="3">
                    <c:v>1.4686273320000001</c:v>
                  </c:pt>
                  <c:pt idx="4">
                    <c:v>1.1111044919999999</c:v>
                  </c:pt>
                  <c:pt idx="5">
                    <c:v>6.4715943899999999</c:v>
                  </c:pt>
                  <c:pt idx="6">
                    <c:v>18.09414414410135</c:v>
                  </c:pt>
                  <c:pt idx="7">
                    <c:v>2.7521427420000002</c:v>
                  </c:pt>
                  <c:pt idx="8">
                    <c:v>1.7082539940000001</c:v>
                  </c:pt>
                  <c:pt idx="9">
                    <c:v>2.9036421890000002</c:v>
                  </c:pt>
                  <c:pt idx="10">
                    <c:v>6.3071812859999996</c:v>
                  </c:pt>
                  <c:pt idx="11">
                    <c:v>18.65568193</c:v>
                  </c:pt>
                  <c:pt idx="12">
                    <c:v>6.045484146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24:$B$36</c:f>
              <c:strCache>
                <c:ptCount val="13"/>
                <c:pt idx="0">
                  <c:v>E51</c:v>
                </c:pt>
                <c:pt idx="1">
                  <c:v>17b</c:v>
                </c:pt>
                <c:pt idx="2">
                  <c:v>17b sCD4</c:v>
                </c:pt>
                <c:pt idx="3">
                  <c:v>C11</c:v>
                </c:pt>
                <c:pt idx="4">
                  <c:v>412D</c:v>
                </c:pt>
                <c:pt idx="5">
                  <c:v>35O22</c:v>
                </c:pt>
                <c:pt idx="6">
                  <c:v>4E10</c:v>
                </c:pt>
                <c:pt idx="7">
                  <c:v>98-6</c:v>
                </c:pt>
                <c:pt idx="8">
                  <c:v>F240</c:v>
                </c:pt>
                <c:pt idx="9">
                  <c:v>5F3</c:v>
                </c:pt>
                <c:pt idx="10">
                  <c:v>240-D</c:v>
                </c:pt>
                <c:pt idx="11">
                  <c:v>246-D</c:v>
                </c:pt>
                <c:pt idx="12">
                  <c:v>1D4</c:v>
                </c:pt>
              </c:strCache>
            </c:strRef>
          </c:cat>
          <c:val>
            <c:numRef>
              <c:f>Sheet1!$F$24:$F$36</c:f>
              <c:numCache>
                <c:formatCode>General</c:formatCode>
                <c:ptCount val="13"/>
                <c:pt idx="0">
                  <c:v>103.32563523332192</c:v>
                </c:pt>
                <c:pt idx="1">
                  <c:v>8.741706593349285</c:v>
                </c:pt>
                <c:pt idx="2">
                  <c:v>13.206327699389206</c:v>
                </c:pt>
                <c:pt idx="3">
                  <c:v>2.9572349690235651</c:v>
                </c:pt>
                <c:pt idx="4">
                  <c:v>4.0263144157759436</c:v>
                </c:pt>
                <c:pt idx="5">
                  <c:v>26.290142100076</c:v>
                </c:pt>
                <c:pt idx="6">
                  <c:v>69.92004604056757</c:v>
                </c:pt>
                <c:pt idx="7">
                  <c:v>108.75852305304312</c:v>
                </c:pt>
                <c:pt idx="8">
                  <c:v>115.20754595122392</c:v>
                </c:pt>
                <c:pt idx="9">
                  <c:v>114.02666120293873</c:v>
                </c:pt>
                <c:pt idx="10">
                  <c:v>23.922045748314584</c:v>
                </c:pt>
                <c:pt idx="11">
                  <c:v>34.686287324002954</c:v>
                </c:pt>
                <c:pt idx="12">
                  <c:v>27.3873747235310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45D-47AB-86B8-C4794450D4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8907664"/>
        <c:axId val="578911584"/>
      </c:barChart>
      <c:catAx>
        <c:axId val="5789076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78911584"/>
        <c:crosses val="autoZero"/>
        <c:auto val="1"/>
        <c:lblAlgn val="ctr"/>
        <c:lblOffset val="100"/>
        <c:noMultiLvlLbl val="0"/>
      </c:catAx>
      <c:valAx>
        <c:axId val="578911584"/>
        <c:scaling>
          <c:orientation val="minMax"/>
          <c:min val="-1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789076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DD9BC3-A87F-4B2E-841D-BB48842DD1C1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500188" y="1143000"/>
            <a:ext cx="38576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DA84F7-CE3F-4B2D-81E5-3229BA54D3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51995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1pPr>
    <a:lvl2pPr marL="190470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2pPr>
    <a:lvl3pPr marL="380939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3pPr>
    <a:lvl4pPr marL="571409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4pPr>
    <a:lvl5pPr marL="761878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5pPr>
    <a:lvl6pPr marL="952348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6pPr>
    <a:lvl7pPr marL="1142817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7pPr>
    <a:lvl8pPr marL="1333287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8pPr>
    <a:lvl9pPr marL="1523756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500188" y="1143000"/>
            <a:ext cx="38576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DDA84F7-CE3F-4B2D-81E5-3229BA54D3A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2216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897890"/>
            <a:ext cx="5829300" cy="191008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2881630"/>
            <a:ext cx="5143500" cy="132461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0184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6749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292100"/>
            <a:ext cx="1478756" cy="464947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292100"/>
            <a:ext cx="4350544" cy="4649470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238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44491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367791"/>
            <a:ext cx="5915025" cy="228219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3671571"/>
            <a:ext cx="5915025" cy="120015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7546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1460500"/>
            <a:ext cx="2914650" cy="348107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1460500"/>
            <a:ext cx="2914650" cy="348107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7732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292101"/>
            <a:ext cx="5915025" cy="106045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344930"/>
            <a:ext cx="2901255" cy="65913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004060"/>
            <a:ext cx="2901255" cy="294767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344930"/>
            <a:ext cx="2915543" cy="65913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004060"/>
            <a:ext cx="2915543" cy="294767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0299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335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4054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65760"/>
            <a:ext cx="2211884" cy="128016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789941"/>
            <a:ext cx="3471863" cy="389890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645920"/>
            <a:ext cx="2211884" cy="304927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2809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65760"/>
            <a:ext cx="2211884" cy="128016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789941"/>
            <a:ext cx="3471863" cy="389890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645920"/>
            <a:ext cx="2211884" cy="304927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6014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292101"/>
            <a:ext cx="5915025" cy="10604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1460500"/>
            <a:ext cx="5915025" cy="34810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5085081"/>
            <a:ext cx="1543050" cy="2921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5085081"/>
            <a:ext cx="2314575" cy="2921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5085081"/>
            <a:ext cx="1543050" cy="2921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4766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1966593" y="2364692"/>
            <a:ext cx="4524840" cy="230572"/>
            <a:chOff x="3818348" y="9770324"/>
            <a:chExt cx="11376740" cy="183676"/>
          </a:xfrm>
        </p:grpSpPr>
        <p:sp>
          <p:nvSpPr>
            <p:cNvPr id="16" name="Rectangle 15"/>
            <p:cNvSpPr/>
            <p:nvPr/>
          </p:nvSpPr>
          <p:spPr>
            <a:xfrm>
              <a:off x="6370283" y="9771020"/>
              <a:ext cx="3749040" cy="182519"/>
            </a:xfrm>
            <a:prstGeom prst="rect">
              <a:avLst/>
            </a:prstGeom>
            <a:solidFill>
              <a:srgbClr val="FED1CC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680712">
                <a:defRPr/>
              </a:pPr>
              <a:endParaRPr lang="en-US" sz="1340" kern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3818348" y="9771512"/>
              <a:ext cx="2377440" cy="182094"/>
            </a:xfrm>
            <a:prstGeom prst="rect">
              <a:avLst/>
            </a:prstGeom>
            <a:solidFill>
              <a:srgbClr val="70AD47">
                <a:lumMod val="20000"/>
                <a:lumOff val="80000"/>
              </a:srgb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680712">
                <a:defRPr/>
              </a:pPr>
              <a:endParaRPr lang="en-US" sz="1340" kern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14161295" y="9771481"/>
              <a:ext cx="1033793" cy="182519"/>
            </a:xfrm>
            <a:prstGeom prst="rect">
              <a:avLst/>
            </a:prstGeom>
            <a:solidFill>
              <a:srgbClr val="FED1CC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680712">
                <a:defRPr/>
              </a:pPr>
              <a:endParaRPr lang="en-US" sz="1340" kern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10261097" y="9770324"/>
              <a:ext cx="3749040" cy="182094"/>
            </a:xfrm>
            <a:prstGeom prst="rect">
              <a:avLst/>
            </a:prstGeom>
            <a:solidFill>
              <a:srgbClr val="70AD47">
                <a:lumMod val="20000"/>
                <a:lumOff val="80000"/>
              </a:srgb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680712">
                <a:defRPr/>
              </a:pPr>
              <a:endParaRPr lang="en-US" sz="1340" kern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20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90764132"/>
              </p:ext>
            </p:extLst>
          </p:nvPr>
        </p:nvGraphicFramePr>
        <p:xfrm>
          <a:off x="625057" y="312286"/>
          <a:ext cx="5981763" cy="25481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" y="47358"/>
            <a:ext cx="5776957" cy="2717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66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</a:t>
            </a:r>
          </a:p>
        </p:txBody>
      </p:sp>
      <p:grpSp>
        <p:nvGrpSpPr>
          <p:cNvPr id="8" name="Group 7"/>
          <p:cNvGrpSpPr/>
          <p:nvPr/>
        </p:nvGrpSpPr>
        <p:grpSpPr>
          <a:xfrm>
            <a:off x="764226" y="4414933"/>
            <a:ext cx="5771078" cy="234080"/>
            <a:chOff x="1030629" y="8100492"/>
            <a:chExt cx="14510138" cy="588543"/>
          </a:xfrm>
        </p:grpSpPr>
        <p:sp>
          <p:nvSpPr>
            <p:cNvPr id="9" name="Rectangle 8"/>
            <p:cNvSpPr/>
            <p:nvPr/>
          </p:nvSpPr>
          <p:spPr>
            <a:xfrm>
              <a:off x="8905661" y="8107842"/>
              <a:ext cx="6635106" cy="581193"/>
            </a:xfrm>
            <a:prstGeom prst="rect">
              <a:avLst/>
            </a:prstGeom>
            <a:solidFill>
              <a:srgbClr val="FED1CC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680712">
                <a:defRPr/>
              </a:pPr>
              <a:endParaRPr lang="en-US" sz="1340" kern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4436606" y="8100492"/>
              <a:ext cx="2235076" cy="553846"/>
            </a:xfrm>
            <a:prstGeom prst="rect">
              <a:avLst/>
            </a:prstGeom>
            <a:solidFill>
              <a:srgbClr val="FED1CC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680712">
                <a:defRPr/>
              </a:pPr>
              <a:endParaRPr lang="en-US" sz="1340" kern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3324688" y="8116653"/>
              <a:ext cx="1033793" cy="558064"/>
            </a:xfrm>
            <a:prstGeom prst="rect">
              <a:avLst/>
            </a:prstGeom>
            <a:solidFill>
              <a:schemeClr val="accent6">
                <a:lumMod val="20000"/>
                <a:lumOff val="80000"/>
              </a:scheme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680712">
                <a:defRPr/>
              </a:pPr>
              <a:endParaRPr lang="en-US" sz="1340" kern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1030629" y="8120672"/>
              <a:ext cx="2248939" cy="505411"/>
            </a:xfrm>
            <a:prstGeom prst="rect">
              <a:avLst/>
            </a:prstGeom>
            <a:solidFill>
              <a:srgbClr val="FED1CC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680712">
                <a:defRPr/>
              </a:pPr>
              <a:endParaRPr lang="en-US" sz="1340" kern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6741953" y="8107045"/>
              <a:ext cx="2103120" cy="557784"/>
            </a:xfrm>
            <a:prstGeom prst="rect">
              <a:avLst/>
            </a:prstGeom>
            <a:solidFill>
              <a:srgbClr val="70AD47">
                <a:lumMod val="20000"/>
                <a:lumOff val="80000"/>
              </a:srgb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680712">
                <a:defRPr/>
              </a:pPr>
              <a:endParaRPr lang="en-US" sz="1340" kern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13691392"/>
              </p:ext>
            </p:extLst>
          </p:nvPr>
        </p:nvGraphicFramePr>
        <p:xfrm>
          <a:off x="354317" y="3188930"/>
          <a:ext cx="6198932" cy="15049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2" name="TextBox 21"/>
          <p:cNvSpPr txBox="1"/>
          <p:nvPr/>
        </p:nvSpPr>
        <p:spPr>
          <a:xfrm rot="16200000">
            <a:off x="-51500" y="1595196"/>
            <a:ext cx="1260412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% of 2G12 Binding</a:t>
            </a:r>
          </a:p>
        </p:txBody>
      </p:sp>
      <p:grpSp>
        <p:nvGrpSpPr>
          <p:cNvPr id="23" name="Group 22"/>
          <p:cNvGrpSpPr/>
          <p:nvPr/>
        </p:nvGrpSpPr>
        <p:grpSpPr>
          <a:xfrm>
            <a:off x="1991528" y="2628907"/>
            <a:ext cx="4474743" cy="443652"/>
            <a:chOff x="3893787" y="9948892"/>
            <a:chExt cx="11250782" cy="1115467"/>
          </a:xfrm>
        </p:grpSpPr>
        <p:sp>
          <p:nvSpPr>
            <p:cNvPr id="24" name="Right Bracket 23"/>
            <p:cNvSpPr/>
            <p:nvPr/>
          </p:nvSpPr>
          <p:spPr>
            <a:xfrm rot="5400000">
              <a:off x="11994579" y="6973661"/>
              <a:ext cx="174760" cy="6125221"/>
            </a:xfrm>
            <a:prstGeom prst="righ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716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Right Bracket 24"/>
            <p:cNvSpPr/>
            <p:nvPr/>
          </p:nvSpPr>
          <p:spPr>
            <a:xfrm rot="5400000">
              <a:off x="4995324" y="8857582"/>
              <a:ext cx="138043" cy="2341117"/>
            </a:xfrm>
            <a:prstGeom prst="righ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716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Right Bracket 25"/>
            <p:cNvSpPr/>
            <p:nvPr/>
          </p:nvSpPr>
          <p:spPr>
            <a:xfrm rot="5400000">
              <a:off x="7524845" y="9015683"/>
              <a:ext cx="155581" cy="2377440"/>
            </a:xfrm>
            <a:prstGeom prst="righ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716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Straight Arrow Connector 26"/>
            <p:cNvCxnSpPr/>
            <p:nvPr/>
          </p:nvCxnSpPr>
          <p:spPr>
            <a:xfrm>
              <a:off x="7741633" y="10277343"/>
              <a:ext cx="0" cy="274320"/>
            </a:xfrm>
            <a:prstGeom prst="straightConnector1">
              <a:avLst/>
            </a:prstGeom>
            <a:ln w="3175">
              <a:tailEnd type="arrow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Straight Arrow Connector 27"/>
            <p:cNvCxnSpPr/>
            <p:nvPr/>
          </p:nvCxnSpPr>
          <p:spPr>
            <a:xfrm>
              <a:off x="4997073" y="10106194"/>
              <a:ext cx="0" cy="295212"/>
            </a:xfrm>
            <a:prstGeom prst="straightConnector1">
              <a:avLst/>
            </a:prstGeom>
            <a:ln w="3175">
              <a:tailEnd type="arrow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>
              <a:off x="4386864" y="10350149"/>
              <a:ext cx="2239067" cy="5091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16" dirty="0">
                  <a:latin typeface="Arial" panose="020B0604020202020204" pitchFamily="34" charset="0"/>
                  <a:cs typeface="Arial" panose="020B0604020202020204" pitchFamily="34" charset="0"/>
                </a:rPr>
                <a:t>V3 </a:t>
              </a:r>
              <a:r>
                <a:rPr lang="en-US" sz="716" dirty="0" err="1">
                  <a:latin typeface="Arial" panose="020B0604020202020204" pitchFamily="34" charset="0"/>
                  <a:cs typeface="Arial" panose="020B0604020202020204" pitchFamily="34" charset="0"/>
                </a:rPr>
                <a:t>glycans</a:t>
              </a:r>
              <a:endParaRPr lang="en-US" sz="71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7213147" y="10555239"/>
              <a:ext cx="5276005" cy="5091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16" dirty="0">
                  <a:latin typeface="Arial" panose="020B0604020202020204" pitchFamily="34" charset="0"/>
                  <a:cs typeface="Arial" panose="020B0604020202020204" pitchFamily="34" charset="0"/>
                </a:rPr>
                <a:t>V3 region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0848857" y="10391253"/>
              <a:ext cx="2652481" cy="5091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16" dirty="0">
                  <a:latin typeface="Arial" panose="020B0604020202020204" pitchFamily="34" charset="0"/>
                  <a:cs typeface="Arial" panose="020B0604020202020204" pitchFamily="34" charset="0"/>
                </a:rPr>
                <a:t>CD4 </a:t>
              </a:r>
              <a:r>
                <a:rPr lang="en-US" sz="716" dirty="0" err="1">
                  <a:latin typeface="Arial" panose="020B0604020202020204" pitchFamily="34" charset="0"/>
                  <a:cs typeface="Arial" panose="020B0604020202020204" pitchFamily="34" charset="0"/>
                </a:rPr>
                <a:t>bs</a:t>
              </a:r>
              <a:endParaRPr lang="en-US" sz="71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" name="Straight Arrow Connector 31"/>
            <p:cNvCxnSpPr/>
            <p:nvPr/>
          </p:nvCxnSpPr>
          <p:spPr>
            <a:xfrm>
              <a:off x="12201748" y="10123651"/>
              <a:ext cx="0" cy="274320"/>
            </a:xfrm>
            <a:prstGeom prst="straightConnector1">
              <a:avLst/>
            </a:prstGeom>
            <a:ln w="3175">
              <a:tailEnd type="arrow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3" name="TextBox 42"/>
          <p:cNvSpPr txBox="1"/>
          <p:nvPr/>
        </p:nvSpPr>
        <p:spPr>
          <a:xfrm>
            <a:off x="3064776" y="1812731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4" name="Left Bracket 43"/>
          <p:cNvSpPr/>
          <p:nvPr/>
        </p:nvSpPr>
        <p:spPr>
          <a:xfrm rot="5400000">
            <a:off x="3137141" y="1866525"/>
            <a:ext cx="36385" cy="154317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7" name="Group 46"/>
          <p:cNvGrpSpPr/>
          <p:nvPr/>
        </p:nvGrpSpPr>
        <p:grpSpPr>
          <a:xfrm>
            <a:off x="4118108" y="1398210"/>
            <a:ext cx="187110" cy="214674"/>
            <a:chOff x="9249189" y="2361296"/>
            <a:chExt cx="387996" cy="539756"/>
          </a:xfrm>
        </p:grpSpPr>
        <p:sp>
          <p:nvSpPr>
            <p:cNvPr id="48" name="TextBox 47"/>
            <p:cNvSpPr txBox="1"/>
            <p:nvPr/>
          </p:nvSpPr>
          <p:spPr>
            <a:xfrm>
              <a:off x="9260204" y="2361296"/>
              <a:ext cx="327089" cy="539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49" name="Left Bracket 48"/>
            <p:cNvSpPr/>
            <p:nvPr/>
          </p:nvSpPr>
          <p:spPr>
            <a:xfrm rot="5400000">
              <a:off x="9397445" y="2522086"/>
              <a:ext cx="91483" cy="387996"/>
            </a:xfrm>
            <a:prstGeom prst="lef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55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2105257" y="1045318"/>
            <a:ext cx="251896" cy="313954"/>
            <a:chOff x="4096864" y="1771381"/>
            <a:chExt cx="718252" cy="789366"/>
          </a:xfrm>
        </p:grpSpPr>
        <p:sp>
          <p:nvSpPr>
            <p:cNvPr id="51" name="TextBox 50"/>
            <p:cNvSpPr txBox="1"/>
            <p:nvPr/>
          </p:nvSpPr>
          <p:spPr>
            <a:xfrm>
              <a:off x="4231626" y="1771381"/>
              <a:ext cx="327088" cy="539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52" name="Left Bracket 51"/>
            <p:cNvSpPr/>
            <p:nvPr/>
          </p:nvSpPr>
          <p:spPr>
            <a:xfrm rot="5400000">
              <a:off x="4375187" y="1782945"/>
              <a:ext cx="129280" cy="685925"/>
            </a:xfrm>
            <a:prstGeom prst="lef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55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488028" y="2020996"/>
              <a:ext cx="327088" cy="539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54" name="Left Bracket 53"/>
            <p:cNvSpPr/>
            <p:nvPr/>
          </p:nvSpPr>
          <p:spPr>
            <a:xfrm rot="5400000">
              <a:off x="4646236" y="2251686"/>
              <a:ext cx="91482" cy="187937"/>
            </a:xfrm>
            <a:prstGeom prst="lef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55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0" name="Group 59"/>
          <p:cNvGrpSpPr/>
          <p:nvPr/>
        </p:nvGrpSpPr>
        <p:grpSpPr>
          <a:xfrm>
            <a:off x="1035889" y="994365"/>
            <a:ext cx="301962" cy="400337"/>
            <a:chOff x="1538437" y="2041476"/>
            <a:chExt cx="759219" cy="1006558"/>
          </a:xfrm>
        </p:grpSpPr>
        <p:sp>
          <p:nvSpPr>
            <p:cNvPr id="61" name="TextBox 60"/>
            <p:cNvSpPr txBox="1"/>
            <p:nvPr/>
          </p:nvSpPr>
          <p:spPr>
            <a:xfrm>
              <a:off x="1677085" y="2041476"/>
              <a:ext cx="327091" cy="539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62" name="Left Bracket 61"/>
            <p:cNvSpPr/>
            <p:nvPr/>
          </p:nvSpPr>
          <p:spPr>
            <a:xfrm rot="5400000">
              <a:off x="1816760" y="2053040"/>
              <a:ext cx="129280" cy="685925"/>
            </a:xfrm>
            <a:prstGeom prst="lef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55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1574809" y="2285243"/>
              <a:ext cx="327091" cy="539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64" name="Left Bracket 63"/>
            <p:cNvSpPr/>
            <p:nvPr/>
          </p:nvSpPr>
          <p:spPr>
            <a:xfrm rot="5400000">
              <a:off x="1737595" y="2414105"/>
              <a:ext cx="91483" cy="387996"/>
            </a:xfrm>
            <a:prstGeom prst="lef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55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1970565" y="2508283"/>
              <a:ext cx="327091" cy="539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66" name="Left Bracket 65"/>
            <p:cNvSpPr/>
            <p:nvPr/>
          </p:nvSpPr>
          <p:spPr>
            <a:xfrm rot="5400000">
              <a:off x="2116396" y="2732587"/>
              <a:ext cx="91482" cy="187937"/>
            </a:xfrm>
            <a:prstGeom prst="lef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55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5662005" y="1541257"/>
            <a:ext cx="186733" cy="214674"/>
            <a:chOff x="13147651" y="2747445"/>
            <a:chExt cx="402525" cy="539756"/>
          </a:xfrm>
        </p:grpSpPr>
        <p:sp>
          <p:nvSpPr>
            <p:cNvPr id="79" name="TextBox 78"/>
            <p:cNvSpPr txBox="1"/>
            <p:nvPr/>
          </p:nvSpPr>
          <p:spPr>
            <a:xfrm>
              <a:off x="13147651" y="2747445"/>
              <a:ext cx="327089" cy="539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80" name="Left Bracket 79"/>
            <p:cNvSpPr/>
            <p:nvPr/>
          </p:nvSpPr>
          <p:spPr>
            <a:xfrm rot="5400000">
              <a:off x="13310436" y="2889077"/>
              <a:ext cx="91483" cy="387996"/>
            </a:xfrm>
            <a:prstGeom prst="lef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55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2721986" y="1480938"/>
            <a:ext cx="130093" cy="214674"/>
            <a:chOff x="5739383" y="2518595"/>
            <a:chExt cx="327090" cy="539754"/>
          </a:xfrm>
        </p:grpSpPr>
        <p:sp>
          <p:nvSpPr>
            <p:cNvPr id="87" name="TextBox 86"/>
            <p:cNvSpPr txBox="1"/>
            <p:nvPr/>
          </p:nvSpPr>
          <p:spPr>
            <a:xfrm>
              <a:off x="5739383" y="2518595"/>
              <a:ext cx="327090" cy="5397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88" name="Left Bracket 87"/>
            <p:cNvSpPr/>
            <p:nvPr/>
          </p:nvSpPr>
          <p:spPr>
            <a:xfrm rot="5400000">
              <a:off x="5891598" y="2749281"/>
              <a:ext cx="91482" cy="187937"/>
            </a:xfrm>
            <a:prstGeom prst="lef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55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9" name="TextBox 88"/>
          <p:cNvSpPr txBox="1"/>
          <p:nvPr/>
        </p:nvSpPr>
        <p:spPr>
          <a:xfrm rot="16200000">
            <a:off x="-130160" y="3738282"/>
            <a:ext cx="1143350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% of 2G12 Binding</a:t>
            </a:r>
          </a:p>
        </p:txBody>
      </p:sp>
      <p:sp>
        <p:nvSpPr>
          <p:cNvPr id="91" name="Right Bracket 90"/>
          <p:cNvSpPr/>
          <p:nvPr/>
        </p:nvSpPr>
        <p:spPr>
          <a:xfrm rot="5400000">
            <a:off x="1879956" y="3652030"/>
            <a:ext cx="42531" cy="2213219"/>
          </a:xfrm>
          <a:prstGeom prst="righ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79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Right Bracket 91"/>
          <p:cNvSpPr/>
          <p:nvPr/>
        </p:nvSpPr>
        <p:spPr>
          <a:xfrm rot="5400000">
            <a:off x="3203919" y="4591504"/>
            <a:ext cx="52240" cy="340647"/>
          </a:xfrm>
          <a:prstGeom prst="righ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79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Right Bracket 92"/>
          <p:cNvSpPr/>
          <p:nvPr/>
        </p:nvSpPr>
        <p:spPr>
          <a:xfrm rot="5400000">
            <a:off x="5192150" y="3448871"/>
            <a:ext cx="43561" cy="2618509"/>
          </a:xfrm>
          <a:prstGeom prst="righ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79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" name="Straight Arrow Connector 93"/>
          <p:cNvCxnSpPr/>
          <p:nvPr/>
        </p:nvCxnSpPr>
        <p:spPr>
          <a:xfrm>
            <a:off x="1467379" y="4853712"/>
            <a:ext cx="0" cy="199206"/>
          </a:xfrm>
          <a:prstGeom prst="straightConnector1">
            <a:avLst/>
          </a:prstGeom>
          <a:ln w="3175">
            <a:tailEnd type="arrow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5" name="Straight Arrow Connector 94"/>
          <p:cNvCxnSpPr>
            <a:stCxn id="92" idx="2"/>
          </p:cNvCxnSpPr>
          <p:nvPr/>
        </p:nvCxnSpPr>
        <p:spPr>
          <a:xfrm>
            <a:off x="3230039" y="4787943"/>
            <a:ext cx="0" cy="327314"/>
          </a:xfrm>
          <a:prstGeom prst="straightConnector1">
            <a:avLst/>
          </a:prstGeom>
          <a:ln w="3175">
            <a:tailEnd type="arrow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6" name="Straight Arrow Connector 95"/>
          <p:cNvCxnSpPr/>
          <p:nvPr/>
        </p:nvCxnSpPr>
        <p:spPr>
          <a:xfrm>
            <a:off x="5055729" y="4775346"/>
            <a:ext cx="0" cy="199206"/>
          </a:xfrm>
          <a:prstGeom prst="straightConnector1">
            <a:avLst/>
          </a:prstGeom>
          <a:ln w="3175">
            <a:tailEnd type="arrow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7" name="TextBox 96"/>
          <p:cNvSpPr txBox="1"/>
          <p:nvPr/>
        </p:nvSpPr>
        <p:spPr>
          <a:xfrm>
            <a:off x="471990" y="5047325"/>
            <a:ext cx="1911327" cy="2024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16" dirty="0">
                <a:latin typeface="Arial" panose="020B0604020202020204" pitchFamily="34" charset="0"/>
                <a:cs typeface="Arial" panose="020B0604020202020204" pitchFamily="34" charset="0"/>
              </a:rPr>
              <a:t>CD4i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2440721" y="5133901"/>
            <a:ext cx="1911327" cy="2024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16" dirty="0">
                <a:latin typeface="Arial" panose="020B0604020202020204" pitchFamily="34" charset="0"/>
                <a:cs typeface="Arial" panose="020B0604020202020204" pitchFamily="34" charset="0"/>
              </a:rPr>
              <a:t>gp41-gp120 interface</a:t>
            </a:r>
          </a:p>
        </p:txBody>
      </p:sp>
      <p:sp>
        <p:nvSpPr>
          <p:cNvPr id="99" name="TextBox 98"/>
          <p:cNvSpPr txBox="1"/>
          <p:nvPr/>
        </p:nvSpPr>
        <p:spPr>
          <a:xfrm>
            <a:off x="2745003" y="4993595"/>
            <a:ext cx="1911327" cy="2024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16" dirty="0">
                <a:latin typeface="Arial" panose="020B0604020202020204" pitchFamily="34" charset="0"/>
                <a:cs typeface="Arial" panose="020B0604020202020204" pitchFamily="34" charset="0"/>
              </a:rPr>
              <a:t>MPER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4100069" y="4990167"/>
            <a:ext cx="1911327" cy="2024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16" dirty="0">
                <a:latin typeface="Arial" panose="020B0604020202020204" pitchFamily="34" charset="0"/>
                <a:cs typeface="Arial" panose="020B0604020202020204" pitchFamily="34" charset="0"/>
              </a:rPr>
              <a:t>Non-neutralizing, gp41</a:t>
            </a:r>
          </a:p>
        </p:txBody>
      </p:sp>
      <p:cxnSp>
        <p:nvCxnSpPr>
          <p:cNvPr id="104" name="Straight Arrow Connector 103"/>
          <p:cNvCxnSpPr/>
          <p:nvPr/>
        </p:nvCxnSpPr>
        <p:spPr>
          <a:xfrm>
            <a:off x="3666098" y="4778829"/>
            <a:ext cx="0" cy="199206"/>
          </a:xfrm>
          <a:prstGeom prst="straightConnector1">
            <a:avLst/>
          </a:prstGeom>
          <a:ln w="3175">
            <a:tailEnd type="arrow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0" name="Right Bracket 109"/>
          <p:cNvSpPr/>
          <p:nvPr/>
        </p:nvSpPr>
        <p:spPr>
          <a:xfrm rot="5400000">
            <a:off x="1423527" y="4183344"/>
            <a:ext cx="35847" cy="1309255"/>
          </a:xfrm>
          <a:prstGeom prst="righ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79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1" name="Straight Arrow Connector 110"/>
          <p:cNvCxnSpPr/>
          <p:nvPr/>
        </p:nvCxnSpPr>
        <p:spPr>
          <a:xfrm>
            <a:off x="2850824" y="4786417"/>
            <a:ext cx="0" cy="199206"/>
          </a:xfrm>
          <a:prstGeom prst="straightConnector1">
            <a:avLst/>
          </a:prstGeom>
          <a:ln w="3175">
            <a:tailEnd type="arrow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2" name="TextBox 111"/>
          <p:cNvSpPr txBox="1"/>
          <p:nvPr/>
        </p:nvSpPr>
        <p:spPr>
          <a:xfrm>
            <a:off x="1872244" y="4980406"/>
            <a:ext cx="1911327" cy="2024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16" dirty="0">
                <a:latin typeface="Arial" panose="020B0604020202020204" pitchFamily="34" charset="0"/>
                <a:cs typeface="Arial" panose="020B0604020202020204" pitchFamily="34" charset="0"/>
              </a:rPr>
              <a:t>gp120</a:t>
            </a:r>
          </a:p>
        </p:txBody>
      </p:sp>
      <p:sp>
        <p:nvSpPr>
          <p:cNvPr id="113" name="Right Bracket 112"/>
          <p:cNvSpPr/>
          <p:nvPr/>
        </p:nvSpPr>
        <p:spPr>
          <a:xfrm rot="5400000">
            <a:off x="3646256" y="4586034"/>
            <a:ext cx="52240" cy="340647"/>
          </a:xfrm>
          <a:prstGeom prst="righ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79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4" name="Group 113"/>
          <p:cNvGrpSpPr/>
          <p:nvPr/>
        </p:nvGrpSpPr>
        <p:grpSpPr>
          <a:xfrm>
            <a:off x="1738504" y="3902851"/>
            <a:ext cx="279167" cy="390550"/>
            <a:chOff x="3480235" y="11983621"/>
            <a:chExt cx="701906" cy="981946"/>
          </a:xfrm>
        </p:grpSpPr>
        <p:sp>
          <p:nvSpPr>
            <p:cNvPr id="115" name="TextBox 114"/>
            <p:cNvSpPr txBox="1"/>
            <p:nvPr/>
          </p:nvSpPr>
          <p:spPr>
            <a:xfrm>
              <a:off x="3745470" y="12211213"/>
              <a:ext cx="327091" cy="539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16" name="Left Bracket 115"/>
            <p:cNvSpPr/>
            <p:nvPr/>
          </p:nvSpPr>
          <p:spPr>
            <a:xfrm rot="5400000">
              <a:off x="3892290" y="12340076"/>
              <a:ext cx="91483" cy="387996"/>
            </a:xfrm>
            <a:prstGeom prst="lef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55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3625272" y="11983621"/>
              <a:ext cx="327091" cy="539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18" name="Left Bracket 117"/>
            <p:cNvSpPr/>
            <p:nvPr/>
          </p:nvSpPr>
          <p:spPr>
            <a:xfrm rot="5400000">
              <a:off x="3758558" y="12011149"/>
              <a:ext cx="129280" cy="685925"/>
            </a:xfrm>
            <a:prstGeom prst="lef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55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3855050" y="12425818"/>
              <a:ext cx="327091" cy="539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20" name="Left Bracket 119"/>
            <p:cNvSpPr/>
            <p:nvPr/>
          </p:nvSpPr>
          <p:spPr>
            <a:xfrm rot="5400000">
              <a:off x="4010460" y="12650228"/>
              <a:ext cx="91482" cy="187937"/>
            </a:xfrm>
            <a:prstGeom prst="lef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55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1" name="TextBox 120"/>
          <p:cNvSpPr txBox="1"/>
          <p:nvPr/>
        </p:nvSpPr>
        <p:spPr>
          <a:xfrm>
            <a:off x="4866687" y="3730081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22" name="Left Bracket 121"/>
          <p:cNvSpPr/>
          <p:nvPr/>
        </p:nvSpPr>
        <p:spPr>
          <a:xfrm rot="5400000">
            <a:off x="4925082" y="3784294"/>
            <a:ext cx="36385" cy="154317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5430167" y="3963524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24" name="Left Bracket 123"/>
          <p:cNvSpPr/>
          <p:nvPr/>
        </p:nvSpPr>
        <p:spPr>
          <a:xfrm rot="5400000">
            <a:off x="5488167" y="4051866"/>
            <a:ext cx="36385" cy="74748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5900875" y="3759528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26" name="Left Bracket 125"/>
          <p:cNvSpPr/>
          <p:nvPr/>
        </p:nvSpPr>
        <p:spPr>
          <a:xfrm rot="5400000">
            <a:off x="5962685" y="3849518"/>
            <a:ext cx="36385" cy="74748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6343354" y="3905359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28" name="Left Bracket 127"/>
          <p:cNvSpPr/>
          <p:nvPr/>
        </p:nvSpPr>
        <p:spPr>
          <a:xfrm rot="5400000">
            <a:off x="6399104" y="3998869"/>
            <a:ext cx="36385" cy="74748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3109685" y="3105447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30" name="Left Bracket 129"/>
          <p:cNvSpPr/>
          <p:nvPr/>
        </p:nvSpPr>
        <p:spPr>
          <a:xfrm rot="5400000">
            <a:off x="3168081" y="3160513"/>
            <a:ext cx="36385" cy="154317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4047758" y="3156089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32" name="Left Bracket 131"/>
          <p:cNvSpPr/>
          <p:nvPr/>
        </p:nvSpPr>
        <p:spPr>
          <a:xfrm rot="5400000">
            <a:off x="4096956" y="3159424"/>
            <a:ext cx="51418" cy="272811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3145922" y="3023148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34" name="Left Bracket 133"/>
          <p:cNvSpPr/>
          <p:nvPr/>
        </p:nvSpPr>
        <p:spPr>
          <a:xfrm rot="5400000">
            <a:off x="3202740" y="3026483"/>
            <a:ext cx="51418" cy="272811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3230088" y="3196637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36" name="Left Bracket 135"/>
          <p:cNvSpPr/>
          <p:nvPr/>
        </p:nvSpPr>
        <p:spPr>
          <a:xfrm rot="5400000">
            <a:off x="3275476" y="3196162"/>
            <a:ext cx="51418" cy="272811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3546104" y="3097725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38" name="Left Bracket 137"/>
          <p:cNvSpPr/>
          <p:nvPr/>
        </p:nvSpPr>
        <p:spPr>
          <a:xfrm rot="5400000">
            <a:off x="3604499" y="3151086"/>
            <a:ext cx="36385" cy="154317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3593770" y="3021342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40" name="Left Bracket 139"/>
          <p:cNvSpPr/>
          <p:nvPr/>
        </p:nvSpPr>
        <p:spPr>
          <a:xfrm rot="5400000">
            <a:off x="3639158" y="3017056"/>
            <a:ext cx="51418" cy="272811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3662697" y="3191020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42" name="Left Bracket 141"/>
          <p:cNvSpPr/>
          <p:nvPr/>
        </p:nvSpPr>
        <p:spPr>
          <a:xfrm rot="5400000">
            <a:off x="3711894" y="3186735"/>
            <a:ext cx="51418" cy="272811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3137687" y="3285693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44" name="Left Bracket 143"/>
          <p:cNvSpPr/>
          <p:nvPr/>
        </p:nvSpPr>
        <p:spPr>
          <a:xfrm rot="5400000">
            <a:off x="3198704" y="3371931"/>
            <a:ext cx="36385" cy="74748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3574105" y="3291310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46" name="Left Bracket 145"/>
          <p:cNvSpPr/>
          <p:nvPr/>
        </p:nvSpPr>
        <p:spPr>
          <a:xfrm rot="5400000">
            <a:off x="3635122" y="3380535"/>
            <a:ext cx="36385" cy="74748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4110521" y="3251438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48" name="Left Bracket 147"/>
          <p:cNvSpPr/>
          <p:nvPr/>
        </p:nvSpPr>
        <p:spPr>
          <a:xfrm rot="5400000">
            <a:off x="4168522" y="3343651"/>
            <a:ext cx="36385" cy="74748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4556046" y="3217950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50" name="Left Bracket 149"/>
          <p:cNvSpPr/>
          <p:nvPr/>
        </p:nvSpPr>
        <p:spPr>
          <a:xfrm rot="5400000">
            <a:off x="4617063" y="3307204"/>
            <a:ext cx="36385" cy="74748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5003793" y="3204713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52" name="Left Bracket 151"/>
          <p:cNvSpPr/>
          <p:nvPr/>
        </p:nvSpPr>
        <p:spPr>
          <a:xfrm rot="5400000">
            <a:off x="5065604" y="3297777"/>
            <a:ext cx="36385" cy="74748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4491796" y="3110215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54" name="Left Bracket 153"/>
          <p:cNvSpPr/>
          <p:nvPr/>
        </p:nvSpPr>
        <p:spPr>
          <a:xfrm rot="5400000">
            <a:off x="4533374" y="3113550"/>
            <a:ext cx="51418" cy="272811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4928215" y="3117835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56" name="Left Bracket 155"/>
          <p:cNvSpPr/>
          <p:nvPr/>
        </p:nvSpPr>
        <p:spPr>
          <a:xfrm rot="5400000">
            <a:off x="4969792" y="3113550"/>
            <a:ext cx="51418" cy="272811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5317306" y="3866881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58" name="Left Bracket 157"/>
          <p:cNvSpPr/>
          <p:nvPr/>
        </p:nvSpPr>
        <p:spPr>
          <a:xfrm rot="5400000">
            <a:off x="5371891" y="3918138"/>
            <a:ext cx="36385" cy="154317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5763769" y="4004719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60" name="Left Bracket 159"/>
          <p:cNvSpPr/>
          <p:nvPr/>
        </p:nvSpPr>
        <p:spPr>
          <a:xfrm rot="5400000">
            <a:off x="5822164" y="4055975"/>
            <a:ext cx="36385" cy="154317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6200187" y="4155328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62" name="Left Bracket 161"/>
          <p:cNvSpPr/>
          <p:nvPr/>
        </p:nvSpPr>
        <p:spPr>
          <a:xfrm rot="5400000">
            <a:off x="6258582" y="4206584"/>
            <a:ext cx="36385" cy="154317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6245782" y="3777410"/>
            <a:ext cx="130093" cy="214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64" name="Left Bracket 163"/>
          <p:cNvSpPr/>
          <p:nvPr/>
        </p:nvSpPr>
        <p:spPr>
          <a:xfrm rot="5400000">
            <a:off x="6291169" y="3776935"/>
            <a:ext cx="51418" cy="272811"/>
          </a:xfrm>
          <a:prstGeom prst="leftBracket">
            <a:avLst/>
          </a:prstGeom>
          <a:ln w="3175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5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868650" y="4179977"/>
            <a:ext cx="316112" cy="2024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16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170" name="TextBox 169"/>
          <p:cNvSpPr txBox="1"/>
          <p:nvPr/>
        </p:nvSpPr>
        <p:spPr>
          <a:xfrm rot="16200000">
            <a:off x="5174486" y="2184210"/>
            <a:ext cx="316112" cy="2024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16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988212" y="2658264"/>
            <a:ext cx="550151" cy="2146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95" dirty="0">
                <a:latin typeface="Arial" panose="020B0604020202020204" pitchFamily="34" charset="0"/>
                <a:cs typeface="Arial" panose="020B0604020202020204" pitchFamily="34" charset="0"/>
              </a:rPr>
              <a:t>1:10000</a:t>
            </a:r>
          </a:p>
        </p:txBody>
      </p:sp>
      <p:sp>
        <p:nvSpPr>
          <p:cNvPr id="165" name="TextBox 164"/>
          <p:cNvSpPr txBox="1"/>
          <p:nvPr/>
        </p:nvSpPr>
        <p:spPr>
          <a:xfrm>
            <a:off x="1230228" y="2355055"/>
            <a:ext cx="232756" cy="1901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36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grpSp>
        <p:nvGrpSpPr>
          <p:cNvPr id="166" name="Group 165"/>
          <p:cNvGrpSpPr/>
          <p:nvPr/>
        </p:nvGrpSpPr>
        <p:grpSpPr>
          <a:xfrm>
            <a:off x="3143236" y="961331"/>
            <a:ext cx="251896" cy="313954"/>
            <a:chOff x="4096864" y="1771381"/>
            <a:chExt cx="718252" cy="789366"/>
          </a:xfrm>
        </p:grpSpPr>
        <p:sp>
          <p:nvSpPr>
            <p:cNvPr id="167" name="TextBox 166"/>
            <p:cNvSpPr txBox="1"/>
            <p:nvPr/>
          </p:nvSpPr>
          <p:spPr>
            <a:xfrm>
              <a:off x="4231626" y="1771381"/>
              <a:ext cx="327088" cy="539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68" name="Left Bracket 167"/>
            <p:cNvSpPr/>
            <p:nvPr/>
          </p:nvSpPr>
          <p:spPr>
            <a:xfrm rot="5400000">
              <a:off x="4375187" y="1782945"/>
              <a:ext cx="129280" cy="685925"/>
            </a:xfrm>
            <a:prstGeom prst="lef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55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TextBox 168"/>
            <p:cNvSpPr txBox="1"/>
            <p:nvPr/>
          </p:nvSpPr>
          <p:spPr>
            <a:xfrm>
              <a:off x="4488028" y="2020996"/>
              <a:ext cx="327088" cy="539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71" name="Left Bracket 170"/>
            <p:cNvSpPr/>
            <p:nvPr/>
          </p:nvSpPr>
          <p:spPr>
            <a:xfrm rot="5400000">
              <a:off x="4646236" y="2251686"/>
              <a:ext cx="91482" cy="187937"/>
            </a:xfrm>
            <a:prstGeom prst="lef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55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2" name="Group 171"/>
          <p:cNvGrpSpPr/>
          <p:nvPr/>
        </p:nvGrpSpPr>
        <p:grpSpPr>
          <a:xfrm>
            <a:off x="4641412" y="1569064"/>
            <a:ext cx="189179" cy="214674"/>
            <a:chOff x="9249189" y="2361296"/>
            <a:chExt cx="387996" cy="539756"/>
          </a:xfrm>
        </p:grpSpPr>
        <p:sp>
          <p:nvSpPr>
            <p:cNvPr id="173" name="TextBox 172"/>
            <p:cNvSpPr txBox="1"/>
            <p:nvPr/>
          </p:nvSpPr>
          <p:spPr>
            <a:xfrm>
              <a:off x="9260205" y="2361296"/>
              <a:ext cx="327089" cy="539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74" name="Left Bracket 173"/>
            <p:cNvSpPr/>
            <p:nvPr/>
          </p:nvSpPr>
          <p:spPr>
            <a:xfrm rot="5400000">
              <a:off x="9397445" y="2522086"/>
              <a:ext cx="91483" cy="387996"/>
            </a:xfrm>
            <a:prstGeom prst="lef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55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5" name="Group 174"/>
          <p:cNvGrpSpPr/>
          <p:nvPr/>
        </p:nvGrpSpPr>
        <p:grpSpPr>
          <a:xfrm>
            <a:off x="4668613" y="928498"/>
            <a:ext cx="251896" cy="313954"/>
            <a:chOff x="4096864" y="1771381"/>
            <a:chExt cx="718252" cy="789366"/>
          </a:xfrm>
        </p:grpSpPr>
        <p:sp>
          <p:nvSpPr>
            <p:cNvPr id="176" name="TextBox 175"/>
            <p:cNvSpPr txBox="1"/>
            <p:nvPr/>
          </p:nvSpPr>
          <p:spPr>
            <a:xfrm>
              <a:off x="4231626" y="1771381"/>
              <a:ext cx="327088" cy="539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77" name="Left Bracket 176"/>
            <p:cNvSpPr/>
            <p:nvPr/>
          </p:nvSpPr>
          <p:spPr>
            <a:xfrm rot="5400000">
              <a:off x="4375187" y="1782945"/>
              <a:ext cx="129280" cy="685925"/>
            </a:xfrm>
            <a:prstGeom prst="lef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55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4488028" y="2020996"/>
              <a:ext cx="327088" cy="539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79" name="Left Bracket 178"/>
            <p:cNvSpPr/>
            <p:nvPr/>
          </p:nvSpPr>
          <p:spPr>
            <a:xfrm rot="5400000">
              <a:off x="4646236" y="2251686"/>
              <a:ext cx="91482" cy="187937"/>
            </a:xfrm>
            <a:prstGeom prst="lef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55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0" name="Group 179"/>
          <p:cNvGrpSpPr/>
          <p:nvPr/>
        </p:nvGrpSpPr>
        <p:grpSpPr>
          <a:xfrm>
            <a:off x="5176476" y="1103505"/>
            <a:ext cx="240559" cy="214674"/>
            <a:chOff x="4096864" y="1771381"/>
            <a:chExt cx="685925" cy="539754"/>
          </a:xfrm>
        </p:grpSpPr>
        <p:sp>
          <p:nvSpPr>
            <p:cNvPr id="181" name="TextBox 180"/>
            <p:cNvSpPr txBox="1"/>
            <p:nvPr/>
          </p:nvSpPr>
          <p:spPr>
            <a:xfrm>
              <a:off x="4231626" y="1771381"/>
              <a:ext cx="327087" cy="5397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82" name="Left Bracket 181"/>
            <p:cNvSpPr/>
            <p:nvPr/>
          </p:nvSpPr>
          <p:spPr>
            <a:xfrm rot="5400000">
              <a:off x="4375187" y="1782945"/>
              <a:ext cx="129280" cy="685925"/>
            </a:xfrm>
            <a:prstGeom prst="lef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55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5" name="Group 184"/>
          <p:cNvGrpSpPr/>
          <p:nvPr/>
        </p:nvGrpSpPr>
        <p:grpSpPr>
          <a:xfrm>
            <a:off x="5686761" y="986195"/>
            <a:ext cx="251896" cy="313954"/>
            <a:chOff x="4096864" y="1771381"/>
            <a:chExt cx="718252" cy="789366"/>
          </a:xfrm>
        </p:grpSpPr>
        <p:sp>
          <p:nvSpPr>
            <p:cNvPr id="186" name="TextBox 185"/>
            <p:cNvSpPr txBox="1"/>
            <p:nvPr/>
          </p:nvSpPr>
          <p:spPr>
            <a:xfrm>
              <a:off x="4231626" y="1771381"/>
              <a:ext cx="327088" cy="539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87" name="Left Bracket 186"/>
            <p:cNvSpPr/>
            <p:nvPr/>
          </p:nvSpPr>
          <p:spPr>
            <a:xfrm rot="5400000">
              <a:off x="4375187" y="1782945"/>
              <a:ext cx="129280" cy="685925"/>
            </a:xfrm>
            <a:prstGeom prst="lef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55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TextBox 187"/>
            <p:cNvSpPr txBox="1"/>
            <p:nvPr/>
          </p:nvSpPr>
          <p:spPr>
            <a:xfrm>
              <a:off x="4488028" y="2020996"/>
              <a:ext cx="327088" cy="539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89" name="Left Bracket 188"/>
            <p:cNvSpPr/>
            <p:nvPr/>
          </p:nvSpPr>
          <p:spPr>
            <a:xfrm rot="5400000">
              <a:off x="4646236" y="2251686"/>
              <a:ext cx="91482" cy="187937"/>
            </a:xfrm>
            <a:prstGeom prst="lef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55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0" name="Group 189"/>
          <p:cNvGrpSpPr/>
          <p:nvPr/>
        </p:nvGrpSpPr>
        <p:grpSpPr>
          <a:xfrm>
            <a:off x="6175067" y="1864473"/>
            <a:ext cx="181684" cy="214674"/>
            <a:chOff x="13147651" y="2818501"/>
            <a:chExt cx="402526" cy="381369"/>
          </a:xfrm>
        </p:grpSpPr>
        <p:sp>
          <p:nvSpPr>
            <p:cNvPr id="191" name="TextBox 190"/>
            <p:cNvSpPr txBox="1"/>
            <p:nvPr/>
          </p:nvSpPr>
          <p:spPr>
            <a:xfrm>
              <a:off x="13147651" y="2818501"/>
              <a:ext cx="327089" cy="381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92" name="Left Bracket 191"/>
            <p:cNvSpPr/>
            <p:nvPr/>
          </p:nvSpPr>
          <p:spPr>
            <a:xfrm rot="5400000">
              <a:off x="13323690" y="2875825"/>
              <a:ext cx="64977" cy="387996"/>
            </a:xfrm>
            <a:prstGeom prst="lef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55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3" name="Group 192"/>
          <p:cNvGrpSpPr/>
          <p:nvPr/>
        </p:nvGrpSpPr>
        <p:grpSpPr>
          <a:xfrm>
            <a:off x="6202742" y="913869"/>
            <a:ext cx="251896" cy="331022"/>
            <a:chOff x="4096864" y="1771381"/>
            <a:chExt cx="718252" cy="710185"/>
          </a:xfrm>
        </p:grpSpPr>
        <p:sp>
          <p:nvSpPr>
            <p:cNvPr id="194" name="TextBox 193"/>
            <p:cNvSpPr txBox="1"/>
            <p:nvPr/>
          </p:nvSpPr>
          <p:spPr>
            <a:xfrm>
              <a:off x="4231626" y="1771381"/>
              <a:ext cx="327088" cy="460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95" name="Left Bracket 194"/>
            <p:cNvSpPr/>
            <p:nvPr/>
          </p:nvSpPr>
          <p:spPr>
            <a:xfrm rot="5400000">
              <a:off x="4375187" y="1782945"/>
              <a:ext cx="129280" cy="685925"/>
            </a:xfrm>
            <a:prstGeom prst="lef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55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TextBox 195"/>
            <p:cNvSpPr txBox="1"/>
            <p:nvPr/>
          </p:nvSpPr>
          <p:spPr>
            <a:xfrm>
              <a:off x="4488028" y="2020998"/>
              <a:ext cx="327088" cy="460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97" name="Left Bracket 196"/>
            <p:cNvSpPr/>
            <p:nvPr/>
          </p:nvSpPr>
          <p:spPr>
            <a:xfrm rot="5400000">
              <a:off x="4651667" y="2214902"/>
              <a:ext cx="91481" cy="187938"/>
            </a:xfrm>
            <a:prstGeom prst="leftBracket">
              <a:avLst/>
            </a:prstGeom>
            <a:ln w="31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55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841901" y="327104"/>
            <a:ext cx="2145139" cy="58477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Env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-)∆808-ND 1 WK RT</a:t>
            </a:r>
          </a:p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Env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-)∆808-ND 1 WK RT + 1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freeze-thaw</a:t>
            </a:r>
          </a:p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Env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-)∆808-ND 1 WK RT + 2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freeze-thaw</a:t>
            </a:r>
          </a:p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Env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-)∆808-ND 1 WK RT + urea</a:t>
            </a:r>
          </a:p>
        </p:txBody>
      </p:sp>
      <p:sp>
        <p:nvSpPr>
          <p:cNvPr id="183" name="TextBox 182"/>
          <p:cNvSpPr txBox="1"/>
          <p:nvPr/>
        </p:nvSpPr>
        <p:spPr>
          <a:xfrm rot="16200000">
            <a:off x="4060318" y="2186928"/>
            <a:ext cx="316112" cy="2024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16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184" name="TextBox 183"/>
          <p:cNvSpPr txBox="1"/>
          <p:nvPr/>
        </p:nvSpPr>
        <p:spPr>
          <a:xfrm rot="16200000">
            <a:off x="4570264" y="2187621"/>
            <a:ext cx="316112" cy="2024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16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198" name="TextBox 197"/>
          <p:cNvSpPr txBox="1"/>
          <p:nvPr/>
        </p:nvSpPr>
        <p:spPr>
          <a:xfrm rot="16200000">
            <a:off x="5075514" y="2187159"/>
            <a:ext cx="316112" cy="2024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16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199" name="TextBox 198"/>
          <p:cNvSpPr txBox="1"/>
          <p:nvPr/>
        </p:nvSpPr>
        <p:spPr>
          <a:xfrm rot="16200000">
            <a:off x="5593444" y="2190798"/>
            <a:ext cx="316112" cy="2024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16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200" name="TextBox 199"/>
          <p:cNvSpPr txBox="1"/>
          <p:nvPr/>
        </p:nvSpPr>
        <p:spPr>
          <a:xfrm rot="16200000">
            <a:off x="6106975" y="2190369"/>
            <a:ext cx="316112" cy="2024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16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201" name="TextBox 200"/>
          <p:cNvSpPr txBox="1"/>
          <p:nvPr/>
        </p:nvSpPr>
        <p:spPr>
          <a:xfrm rot="16200000">
            <a:off x="3532640" y="2187573"/>
            <a:ext cx="316112" cy="2024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16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202" name="TextBox 201"/>
          <p:cNvSpPr txBox="1"/>
          <p:nvPr/>
        </p:nvSpPr>
        <p:spPr>
          <a:xfrm rot="16200000">
            <a:off x="3026207" y="2186815"/>
            <a:ext cx="316112" cy="2024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16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203" name="TextBox 202"/>
          <p:cNvSpPr txBox="1"/>
          <p:nvPr/>
        </p:nvSpPr>
        <p:spPr>
          <a:xfrm rot="16200000">
            <a:off x="2518551" y="2187158"/>
            <a:ext cx="316112" cy="2024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16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204" name="TextBox 203"/>
          <p:cNvSpPr txBox="1"/>
          <p:nvPr/>
        </p:nvSpPr>
        <p:spPr>
          <a:xfrm rot="16200000">
            <a:off x="2009258" y="2184910"/>
            <a:ext cx="316112" cy="2024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16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205" name="TextBox 204"/>
          <p:cNvSpPr txBox="1"/>
          <p:nvPr/>
        </p:nvSpPr>
        <p:spPr>
          <a:xfrm rot="16200000">
            <a:off x="975235" y="2187489"/>
            <a:ext cx="316112" cy="2024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16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</p:spTree>
    <p:extLst>
      <p:ext uri="{BB962C8B-B14F-4D97-AF65-F5344CB8AC3E}">
        <p14:creationId xmlns:p14="http://schemas.microsoft.com/office/powerpoint/2010/main" val="19233038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430</TotalTime>
  <Words>122</Words>
  <Application>Microsoft Office PowerPoint</Application>
  <PresentationFormat>Custom</PresentationFormat>
  <Paragraphs>7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sten Witt</dc:creator>
  <cp:lastModifiedBy>kristenwitt@outlook.com</cp:lastModifiedBy>
  <cp:revision>457</cp:revision>
  <dcterms:created xsi:type="dcterms:W3CDTF">2016-04-05T18:18:37Z</dcterms:created>
  <dcterms:modified xsi:type="dcterms:W3CDTF">2016-12-11T16:54:33Z</dcterms:modified>
</cp:coreProperties>
</file>